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95.xml" ContentType="application/vnd.openxmlformats-officedocument.presentationml.slideLayout+xml"/>
  <Override PartName="/ppt/media/image12.jpeg" ContentType="image/jpeg"/>
  <Override PartName="/ppt/media/image7.jpeg" ContentType="image/jpeg"/>
  <Override PartName="/ppt/media/image11.jpeg" ContentType="image/jpeg"/>
  <Override PartName="/ppt/media/image9.jpeg" ContentType="image/jpeg"/>
  <Override PartName="/ppt/media/image6.jpeg" ContentType="image/jpeg"/>
  <Override PartName="/ppt/media/image10.jpeg" ContentType="image/jpeg"/>
  <Override PartName="/ppt/media/image8.jpeg" ContentType="image/jpeg"/>
  <Override PartName="/ppt/media/image5.jpeg" ContentType="image/jpeg"/>
  <Override PartName="/ppt/media/image13.jpeg" ContentType="image/jpeg"/>
  <Override PartName="/ppt/media/image23.png" ContentType="image/png"/>
  <Override PartName="/ppt/media/image4.png" ContentType="image/png"/>
  <Override PartName="/ppt/media/image24.png" ContentType="image/png"/>
  <Override PartName="/ppt/media/image18.jpeg" ContentType="image/jpeg"/>
  <Override PartName="/ppt/media/image22.png" ContentType="image/png"/>
  <Override PartName="/ppt/media/image19.jpeg" ContentType="image/jpeg"/>
  <Override PartName="/ppt/media/image21.png" ContentType="image/png"/>
  <Override PartName="/ppt/media/image20.jpeg" ContentType="image/jpeg"/>
  <Override PartName="/ppt/media/image3.wmf" ContentType="image/x-wmf"/>
  <Override PartName="/ppt/media/image15.jpeg" ContentType="image/jpeg"/>
  <Override PartName="/ppt/media/image17.jpeg" ContentType="image/jpeg"/>
  <Override PartName="/ppt/media/image16.jpeg" ContentType="image/jpeg"/>
  <Override PartName="/ppt/media/image14.jpeg" ContentType="image/jpeg"/>
  <Override PartName="/ppt/media/image1.wmf" ContentType="image/x-wmf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</p:sldMasterIdLst>
  <p:sldIdLst>
    <p:sldId id="256" r:id="rId15"/>
  </p:sldIdLst>
  <p:sldSz cx="6119813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" Target="slides/slide1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AB3CA-C199-45B2-BE02-2ABABB8531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721325-38AF-4503-833D-EA45FF3F8D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CA1A6F72-EDA9-4D21-836A-2868E3D70C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D23E511-97EF-441E-B301-C8CEB163D5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272225E9-58D1-4915-97DF-EEBD43C8EF6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285F3CF-197C-4953-82EE-9E99910476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1180907-2887-46C5-BCA9-3D360B5CCA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DC28349B-A883-4F83-8E47-A11CB08640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9269818-C4C3-4850-B608-43F1697B84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06F3B3BD-4E65-4B2E-B6CF-0CDD9BCF98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F4E62789-1E46-4A17-BA53-D56F2D37EE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6FAC9C0E-CBD7-4583-8E4E-F557218A19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9F4974-F013-4A0C-A6A3-D754FABF8C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D1F49C5F-6351-4059-A00A-AE9CF74460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B2379CF-CEC5-4F94-9A94-383BCBD70D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C8FB887-EDDF-4FBB-B344-0309CFFA54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DE1C8DE5-DA99-413D-87CF-5FA81D84AE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D45A2861-C669-467D-984D-62CEA82BAA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14A4CF48-DDA7-4AC0-8917-4E15BA8716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4C3A9A3-1D75-44BB-BE3C-51A467A4D7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8744F0C-9E03-4151-A4AA-719A6AA1FA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F3430C3-ACB4-4376-9007-65DFD010BC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1E9E9D8B-2173-47F5-A8EE-590A5D915F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C3FF18-21F2-4D65-938E-A75CBFC1A0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9C7357D-F3D3-44D9-9A2C-E3390D0864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974E190-BB16-43D1-94D2-65241728A6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6143848E-CDD4-4DBD-BB6E-6ADFE08099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EDABC8E-060D-4D7E-B38B-41ED84D6B0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7028999-0D61-4CA3-8A3C-5068CC708A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DE25306-3A88-45A4-9A79-11E0933B3A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91076D8-8F4B-4459-98B7-657F2C5FE3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9B02E51-A41C-49A6-A4F2-84083F4C3B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431C4B3-2BAF-4678-B603-F39B7A8689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8B07C95-79F8-446D-9FA1-C5B400A11C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E90A20E-5595-46DF-9BF6-6B5FCB3F08E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0E1580F4-9604-47AC-BBED-A760DFD488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33443A40-A1B9-425C-938F-0DBE386EE3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93A0D43-4F24-4D6C-9401-B3DC92F610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BDF6EBD8-1EC0-49C6-9924-F31C067AAFE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5F36661-6F9E-4FAE-B385-E3FD4F4F85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067E0D4E-AE81-4784-B9D4-512A478CF6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78755A3E-8281-40C6-9A06-F8912913F2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4ABFFAF8-C161-4E14-8117-67D8915B38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16A629A-8005-4866-96DB-E30A8F7DFC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A9E05B1-79EF-4C7D-AA2F-4D7D1918C0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16F970D-EB12-4AB1-A360-5DD2DC5DFF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A3FBFD2-950D-4D61-9CD0-4E98DFEB88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0D5A3418-83EF-48DB-8CF0-0755400858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B6020D66-AAD9-4E49-98D8-00A8388335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984C3270-76D1-42FF-B855-FEF01ABADB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5907A6B0-52A5-4962-A5D7-0239D06EB9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20AEA64A-B5E5-4C81-871C-7B540EB720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EBE34E95-99B5-4A66-A2FD-D0359B2D03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6EC1405F-798F-4352-8C24-22E5D5DF55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D08517E3-AF40-4FEF-9B6F-0FDC14ACC9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8C2501E7-E6E2-4811-979A-CCE94F8295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AFDB460-E748-47FE-AE89-92F949762B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5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9B6E4C08-DA93-4A3B-989D-91D0A966B3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641EC697-D81B-4D4C-854A-7ACDC8A57F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BB0ADD72-741C-4CED-A20A-C334638540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62CBD8FB-E0F9-4C0B-B861-1AB301F6F7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8F362BA2-D3D9-4F23-8318-2E94D76BF0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4534A0CE-4EE8-4B18-9E58-EA6DC5F14B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55F6482A-842F-44D8-AED0-76BCCF3131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FF96052-7ABA-4A2B-9A05-1F08E74C19C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B1F6B14-12D5-45B5-84D8-7D5AA7E7EC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F9EFFD6-69B9-47A5-93DC-87D0AB9F93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1017521-ACAE-4A2F-9FBD-A2A29B80FF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3318EB-AB1A-4BBD-8DF4-3CFFD02E26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1FDA900-3311-48CD-A57A-0447DDC73A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3F40213-32EE-45AF-99DD-E997105329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9365F54-5CAC-4CA0-BFCA-83C0BAE8AF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A2ED496-D378-454B-BB94-79948A7A0D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EAF7C02-C24D-499C-A3F6-0F5A39A09C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EDC465D-8CEF-497C-AC85-94A960F3743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FB5F53D-A1B1-4366-AC05-0168614B2C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F00645C-2DF7-4776-9AA7-F1AC12C256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2584BCB-7B27-453A-A840-FEB0B4ED45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E5626EE-4042-44DB-9446-4893283E04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A4D9A-DC55-48FD-AF10-70BE8ED482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ED57625-FBFD-4E56-836B-C348F1C379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08A8EEC-11CA-437E-9B52-47C480D14D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22195CE-295C-4A09-BC28-DF46BD357A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13DC96A-EE12-44A9-9594-A4FCB65685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9019D716-064C-4923-BAC7-C0B0EAC9F1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F8E1823-4BE6-4BE7-A7B8-F41C7FDB27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201BCC0-481E-48BC-9432-81E653E3DB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7064B7DC-A029-404D-BA0F-D672987456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2F66320-798E-473D-9F58-87D12EEDCC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BD047A7-D222-4275-90C4-7E120ACA4B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CC541-1E3C-407A-9AFD-32D54BD259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2804FEA-7E12-4369-B4FA-3FF56C10AA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BA45140-E2F2-443B-B401-3ED88D0A8AD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E8A9829-DD36-49A7-A5F1-4F10C6A35E9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EEB493C-171A-47E7-9997-F49D363EE1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B1EB1AD-48B6-4F94-AF2B-5F17781D78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5326294-951E-4749-960F-99A65E8B0A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B631ADA-7868-4ACE-BAEB-0F3734B55B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0FE1978-11F9-4254-A19E-A608B5E0B2A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89E403F-9508-43D6-AB9D-90AAFAEBBA6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C2837E4-46E8-4940-B983-85350B517D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983720-D3D1-47B3-B9DE-C0CB1D72C4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71ED93B-1195-40CB-B19F-93471679C2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D80F6E6-FE81-46DE-9587-336D95AB13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523D173-F9FB-4139-81FF-4E05FCBC27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62803E7-4493-4668-ABDA-D30DB7ABEC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FE82442-0E4E-4AFD-BA4F-8CB176C190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1AD2E16-F9B5-4B86-8647-3DE5A43A54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D2EABA8-EA36-4FFB-99EE-00A8096147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EA3C2141-D07C-4DA3-B997-41C3B81845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4759857-B595-4F93-933C-DF708D61EE8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A9A7F10-46FC-4FCE-8AE0-3080995254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DCD53E-7AE9-4578-8D6E-CDEA624379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4BEBA96-E28A-4823-AFF8-ECDCB395FA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A7B98F4-AAD3-44A1-AE94-4F5E262479F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0BDD724-1109-45F2-8C6C-13DA35CE7D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7F25633-D6DC-4C57-A233-710CF98A53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6723A88-07DB-43D1-94C0-4F8AE43BB8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258DD6C-8D6E-4878-8812-87B2676201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37A8848-67C4-4700-8319-7148E52866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B29B65C-E3E6-40D8-B921-D44C7417ED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0F84FC93-BBA7-481F-AF1C-261ED9E9F4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237A575-A5E3-4811-AB49-F88F82E633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9F38D-5571-486C-8A03-5391A71D88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3F439DD3-805F-4CB2-AA92-44D41092FA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5C2A6F48-8C59-4050-BC29-F070FD1A9B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4C02BDA-E8FF-4324-82A0-65C3DFEAEA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A235945-95E7-48A1-B789-7C059D1B72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8474A25-6067-4468-8C47-9271AA0EB4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853B0318-F4A4-4706-8A1E-98D03A34BE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A832309E-41E4-4048-8E50-AFBBFEB94D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D1A6CF5-D56D-4F55-A412-AA8D8165E6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DC2EF29-C2EA-4B21-B556-09D21D8681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C3558CB-68E8-407D-B3D7-612CC6D7FB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B1B410-E214-45E6-86F8-223BD0AFA3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8B3197E0-06E6-41A7-BFF1-663220F137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6AEB869-76A5-47D6-80C0-E538CE293C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91D49F1-7AC0-49F0-89A1-340D129E03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362C6DFF-0602-4DFC-BB4A-F1546FF3D1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2674460-5AB8-4D15-B145-794E62FAE4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BB41FE7-78BF-496E-ABE0-73D48C6A09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BD16A08-7E46-4D89-A4C3-7F52C1C807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DEAD39B-6255-4A7D-82F3-C325C2B5DA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32EF480-1838-4BB4-BAF5-4B872C1D88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8BC0AC4-4026-41B8-8F68-4CE354C1CB6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561445-2EF2-4900-BFA5-7514C912C2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3A2173C-1812-403D-86E6-25C4E26188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18BA7E8-5B48-48B6-8B00-DFC2B20AEE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A96E778-318A-477B-8ADE-3D71FC36B9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AEFB402-69EF-45E3-8B82-7AE97AA067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B7CFB74-C11B-44D4-A65B-C39D4A145C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166B6D68-C9B0-45EC-AFFA-3B2214098CF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8A93DB7-DCAE-4AA8-9881-3AF98B4B75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8FAE5CA-3243-41EB-8217-BC53E461A0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457950D-1A47-497F-BDEB-D04B46ED0F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C0DC62BC-EA9E-4E05-AEF6-2424123159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40788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816120" indent="-4082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224000" indent="-81612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06360" y="8475480"/>
            <a:ext cx="14270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90880" y="8475480"/>
            <a:ext cx="19382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386240" y="8475480"/>
            <a:ext cx="14270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8FC0347-6CDD-4730-A9A8-B0412EA7CF5A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78EFA31-380D-4349-A4C7-9FEE1407D557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2CD6C3E-AD87-474B-987D-55B4AAB5BD45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A1E8151-4152-45ED-BB51-B32A64D7D70B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PlaceHolder 3"/>
          <p:cNvSpPr>
            <a:spLocks noGrp="1"/>
          </p:cNvSpPr>
          <p:nvPr>
            <p:ph type="dt" idx="37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PlaceHolder 4"/>
          <p:cNvSpPr>
            <a:spLocks noGrp="1"/>
          </p:cNvSpPr>
          <p:nvPr>
            <p:ph type="ftr" idx="38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PlaceHolder 5"/>
          <p:cNvSpPr>
            <a:spLocks noGrp="1"/>
          </p:cNvSpPr>
          <p:nvPr>
            <p:ph type="sldNum" idx="39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C705FEF-84FD-4861-BDBE-E1FE43FB5AE4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03DAF1-A232-4DBA-AF2F-47B4051BFF8B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D086CEC-C674-407E-A0DE-26BF7518E374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825AE7A-2BAE-41F2-911F-A4FE7F57CE80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94FC831-596E-46CA-8275-B931FD4004B9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96FC7F6-BA8B-4B80-ACDA-7304BDB53CC3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B08C792-2717-4628-919E-01530E686EFC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CAFDBC4-344A-4A0A-AF8A-F2E672B29549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DA700D2-2567-463D-A4D7-A9FFE02B2561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wmf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3.png"/><Relationship Id="rId27" Type="http://schemas.openxmlformats.org/officeDocument/2006/relationships/slideLayout" Target="../slideLayouts/slideLayout9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3" name="Text Box 2"/>
          <p:cNvSpPr/>
          <p:nvPr/>
        </p:nvSpPr>
        <p:spPr>
          <a:xfrm>
            <a:off x="355680" y="111240"/>
            <a:ext cx="40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文本框 130"/>
          <p:cNvSpPr/>
          <p:nvPr/>
        </p:nvSpPr>
        <p:spPr>
          <a:xfrm>
            <a:off x="5243040" y="852012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5" name="组 13"/>
          <p:cNvGrpSpPr/>
          <p:nvPr/>
        </p:nvGrpSpPr>
        <p:grpSpPr>
          <a:xfrm>
            <a:off x="671760" y="4557600"/>
            <a:ext cx="2185560" cy="1814400"/>
            <a:chOff x="671760" y="4557600"/>
            <a:chExt cx="2185560" cy="1814400"/>
          </a:xfrm>
        </p:grpSpPr>
        <p:pic>
          <p:nvPicPr>
            <p:cNvPr id="536" name="图片 4" descr=""/>
            <p:cNvPicPr/>
            <p:nvPr/>
          </p:nvPicPr>
          <p:blipFill>
            <a:blip r:embed="rId1"/>
            <a:stretch/>
          </p:blipFill>
          <p:spPr>
            <a:xfrm>
              <a:off x="1298520" y="4782240"/>
              <a:ext cx="1532160" cy="1264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7" name="文本框 61" descr=""/>
            <p:cNvPicPr/>
            <p:nvPr/>
          </p:nvPicPr>
          <p:blipFill>
            <a:blip r:embed="rId2"/>
            <a:stretch/>
          </p:blipFill>
          <p:spPr>
            <a:xfrm>
              <a:off x="903240" y="4557600"/>
              <a:ext cx="336600" cy="1406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8" name="文本框 144"/>
            <p:cNvSpPr/>
            <p:nvPr/>
          </p:nvSpPr>
          <p:spPr>
            <a:xfrm>
              <a:off x="1043280" y="475164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9" name="文本框 145"/>
            <p:cNvSpPr/>
            <p:nvPr/>
          </p:nvSpPr>
          <p:spPr>
            <a:xfrm>
              <a:off x="1118160" y="497448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0" name="文本框 146"/>
            <p:cNvSpPr/>
            <p:nvPr/>
          </p:nvSpPr>
          <p:spPr>
            <a:xfrm>
              <a:off x="1118160" y="51973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1" name="文本框 147"/>
            <p:cNvSpPr/>
            <p:nvPr/>
          </p:nvSpPr>
          <p:spPr>
            <a:xfrm>
              <a:off x="1118160" y="54201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2" name="文本框 148"/>
            <p:cNvSpPr/>
            <p:nvPr/>
          </p:nvSpPr>
          <p:spPr>
            <a:xfrm>
              <a:off x="1118160" y="58658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3" name="文本框 150"/>
            <p:cNvSpPr/>
            <p:nvPr/>
          </p:nvSpPr>
          <p:spPr>
            <a:xfrm>
              <a:off x="671760" y="5973480"/>
              <a:ext cx="775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(ng/mL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4" name="文本框 172"/>
            <p:cNvSpPr/>
            <p:nvPr/>
          </p:nvSpPr>
          <p:spPr>
            <a:xfrm>
              <a:off x="1118160" y="56430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5" name="文本框 14340"/>
            <p:cNvSpPr/>
            <p:nvPr/>
          </p:nvSpPr>
          <p:spPr>
            <a:xfrm>
              <a:off x="1449720" y="59738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6" name="文本框 14341"/>
            <p:cNvSpPr/>
            <p:nvPr/>
          </p:nvSpPr>
          <p:spPr>
            <a:xfrm>
              <a:off x="1718280" y="597384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7" name="文本框 14342"/>
            <p:cNvSpPr/>
            <p:nvPr/>
          </p:nvSpPr>
          <p:spPr>
            <a:xfrm>
              <a:off x="2056320" y="597384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8" name="文本框 14344"/>
            <p:cNvSpPr/>
            <p:nvPr/>
          </p:nvSpPr>
          <p:spPr>
            <a:xfrm>
              <a:off x="2394360" y="597384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49" name="组 173"/>
            <p:cNvGrpSpPr/>
            <p:nvPr/>
          </p:nvGrpSpPr>
          <p:grpSpPr>
            <a:xfrm>
              <a:off x="1595520" y="5181840"/>
              <a:ext cx="306360" cy="35280"/>
              <a:chOff x="1595520" y="5181840"/>
              <a:chExt cx="306360" cy="35280"/>
            </a:xfrm>
          </p:grpSpPr>
          <p:sp>
            <p:nvSpPr>
              <p:cNvPr id="550" name="直线连接符 85"/>
              <p:cNvSpPr/>
              <p:nvPr/>
            </p:nvSpPr>
            <p:spPr>
              <a:xfrm>
                <a:off x="1595520" y="5181840"/>
                <a:ext cx="306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1" name="直线连接符 86"/>
              <p:cNvSpPr/>
              <p:nvPr/>
            </p:nvSpPr>
            <p:spPr>
              <a:xfrm>
                <a:off x="1596960" y="5181840"/>
                <a:ext cx="0" cy="35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2" name="直线连接符 87"/>
              <p:cNvSpPr/>
              <p:nvPr/>
            </p:nvSpPr>
            <p:spPr>
              <a:xfrm>
                <a:off x="1899000" y="5181840"/>
                <a:ext cx="0" cy="35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53" name="组 173"/>
            <p:cNvGrpSpPr/>
            <p:nvPr/>
          </p:nvGrpSpPr>
          <p:grpSpPr>
            <a:xfrm>
              <a:off x="1899000" y="5035680"/>
              <a:ext cx="306360" cy="35280"/>
              <a:chOff x="1899000" y="5035680"/>
              <a:chExt cx="306360" cy="35280"/>
            </a:xfrm>
          </p:grpSpPr>
          <p:sp>
            <p:nvSpPr>
              <p:cNvPr id="554" name="直线连接符 82"/>
              <p:cNvSpPr/>
              <p:nvPr/>
            </p:nvSpPr>
            <p:spPr>
              <a:xfrm>
                <a:off x="1899000" y="5035680"/>
                <a:ext cx="306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5" name="直线连接符 83"/>
              <p:cNvSpPr/>
              <p:nvPr/>
            </p:nvSpPr>
            <p:spPr>
              <a:xfrm>
                <a:off x="1901880" y="5035680"/>
                <a:ext cx="0" cy="35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6" name="直线连接符 84"/>
              <p:cNvSpPr/>
              <p:nvPr/>
            </p:nvSpPr>
            <p:spPr>
              <a:xfrm>
                <a:off x="2202480" y="5035680"/>
                <a:ext cx="0" cy="35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57" name="组 173"/>
            <p:cNvGrpSpPr/>
            <p:nvPr/>
          </p:nvGrpSpPr>
          <p:grpSpPr>
            <a:xfrm>
              <a:off x="2230920" y="5035320"/>
              <a:ext cx="306360" cy="35280"/>
              <a:chOff x="2230920" y="5035320"/>
              <a:chExt cx="306360" cy="35280"/>
            </a:xfrm>
          </p:grpSpPr>
          <p:sp>
            <p:nvSpPr>
              <p:cNvPr id="558" name="直线连接符 79"/>
              <p:cNvSpPr/>
              <p:nvPr/>
            </p:nvSpPr>
            <p:spPr>
              <a:xfrm>
                <a:off x="2230920" y="5035320"/>
                <a:ext cx="306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9" name="直线连接符 80"/>
              <p:cNvSpPr/>
              <p:nvPr/>
            </p:nvSpPr>
            <p:spPr>
              <a:xfrm>
                <a:off x="2232360" y="5035320"/>
                <a:ext cx="0" cy="35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0" name="直线连接符 81"/>
              <p:cNvSpPr/>
              <p:nvPr/>
            </p:nvSpPr>
            <p:spPr>
              <a:xfrm>
                <a:off x="2534400" y="5035320"/>
                <a:ext cx="0" cy="35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520" bIns="-11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61" name="文本框 151"/>
            <p:cNvSpPr/>
            <p:nvPr/>
          </p:nvSpPr>
          <p:spPr>
            <a:xfrm>
              <a:off x="1909440" y="4867200"/>
              <a:ext cx="284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2" name="文本框 161"/>
            <p:cNvSpPr/>
            <p:nvPr/>
          </p:nvSpPr>
          <p:spPr>
            <a:xfrm>
              <a:off x="1634040" y="5006520"/>
              <a:ext cx="231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3" name="文本框 151"/>
            <p:cNvSpPr/>
            <p:nvPr/>
          </p:nvSpPr>
          <p:spPr>
            <a:xfrm>
              <a:off x="2230200" y="4837680"/>
              <a:ext cx="62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S p=0.1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64" name="组 12"/>
          <p:cNvGrpSpPr/>
          <p:nvPr/>
        </p:nvGrpSpPr>
        <p:grpSpPr>
          <a:xfrm>
            <a:off x="3332520" y="4468680"/>
            <a:ext cx="2179080" cy="1906560"/>
            <a:chOff x="3332520" y="4468680"/>
            <a:chExt cx="2179080" cy="1906560"/>
          </a:xfrm>
        </p:grpSpPr>
        <p:pic>
          <p:nvPicPr>
            <p:cNvPr id="565" name="图片 8" descr=""/>
            <p:cNvPicPr/>
            <p:nvPr/>
          </p:nvPicPr>
          <p:blipFill>
            <a:blip r:embed="rId3"/>
            <a:stretch/>
          </p:blipFill>
          <p:spPr>
            <a:xfrm>
              <a:off x="3934800" y="4763520"/>
              <a:ext cx="1556280" cy="12855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66" name="组 173"/>
            <p:cNvGrpSpPr/>
            <p:nvPr/>
          </p:nvGrpSpPr>
          <p:grpSpPr>
            <a:xfrm>
              <a:off x="4239720" y="5122440"/>
              <a:ext cx="311040" cy="36000"/>
              <a:chOff x="4239720" y="5122440"/>
              <a:chExt cx="311040" cy="36000"/>
            </a:xfrm>
          </p:grpSpPr>
          <p:sp>
            <p:nvSpPr>
              <p:cNvPr id="567" name="直线连接符 113"/>
              <p:cNvSpPr/>
              <p:nvPr/>
            </p:nvSpPr>
            <p:spPr>
              <a:xfrm>
                <a:off x="4239720" y="5122440"/>
                <a:ext cx="311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8" name="直线连接符 114"/>
              <p:cNvSpPr/>
              <p:nvPr/>
            </p:nvSpPr>
            <p:spPr>
              <a:xfrm>
                <a:off x="4241160" y="5122440"/>
                <a:ext cx="0" cy="36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9" name="直线连接符 115"/>
              <p:cNvSpPr/>
              <p:nvPr/>
            </p:nvSpPr>
            <p:spPr>
              <a:xfrm>
                <a:off x="4546080" y="5122440"/>
                <a:ext cx="0" cy="36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70" name="组 173"/>
            <p:cNvGrpSpPr/>
            <p:nvPr/>
          </p:nvGrpSpPr>
          <p:grpSpPr>
            <a:xfrm>
              <a:off x="4548240" y="4868280"/>
              <a:ext cx="311040" cy="36000"/>
              <a:chOff x="4548240" y="4868280"/>
              <a:chExt cx="311040" cy="36000"/>
            </a:xfrm>
          </p:grpSpPr>
          <p:sp>
            <p:nvSpPr>
              <p:cNvPr id="571" name="直线连接符 110"/>
              <p:cNvSpPr/>
              <p:nvPr/>
            </p:nvSpPr>
            <p:spPr>
              <a:xfrm>
                <a:off x="4548240" y="4868280"/>
                <a:ext cx="311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2" name="直线连接符 111"/>
              <p:cNvSpPr/>
              <p:nvPr/>
            </p:nvSpPr>
            <p:spPr>
              <a:xfrm>
                <a:off x="4549680" y="4868280"/>
                <a:ext cx="0" cy="36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3" name="直线连接符 112"/>
              <p:cNvSpPr/>
              <p:nvPr/>
            </p:nvSpPr>
            <p:spPr>
              <a:xfrm>
                <a:off x="4856400" y="4868280"/>
                <a:ext cx="0" cy="36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74" name="组 173"/>
            <p:cNvGrpSpPr/>
            <p:nvPr/>
          </p:nvGrpSpPr>
          <p:grpSpPr>
            <a:xfrm>
              <a:off x="4885560" y="4867560"/>
              <a:ext cx="311040" cy="36000"/>
              <a:chOff x="4885560" y="4867560"/>
              <a:chExt cx="311040" cy="36000"/>
            </a:xfrm>
          </p:grpSpPr>
          <p:sp>
            <p:nvSpPr>
              <p:cNvPr id="575" name="直线连接符 107"/>
              <p:cNvSpPr/>
              <p:nvPr/>
            </p:nvSpPr>
            <p:spPr>
              <a:xfrm>
                <a:off x="4885560" y="4867560"/>
                <a:ext cx="3110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6" name="直线连接符 108"/>
              <p:cNvSpPr/>
              <p:nvPr/>
            </p:nvSpPr>
            <p:spPr>
              <a:xfrm>
                <a:off x="4887000" y="4867560"/>
                <a:ext cx="0" cy="36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7" name="直线连接符 109"/>
              <p:cNvSpPr/>
              <p:nvPr/>
            </p:nvSpPr>
            <p:spPr>
              <a:xfrm>
                <a:off x="5193720" y="4867560"/>
                <a:ext cx="0" cy="36000"/>
              </a:xfrm>
              <a:prstGeom prst="line">
                <a:avLst/>
              </a:prstGeom>
              <a:ln w="1260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78" name="文本框 151"/>
            <p:cNvSpPr/>
            <p:nvPr/>
          </p:nvSpPr>
          <p:spPr>
            <a:xfrm>
              <a:off x="4558680" y="4696920"/>
              <a:ext cx="284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9" name="文本框 161"/>
            <p:cNvSpPr/>
            <p:nvPr/>
          </p:nvSpPr>
          <p:spPr>
            <a:xfrm>
              <a:off x="4278960" y="4944240"/>
              <a:ext cx="231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0" name="文本框 151"/>
            <p:cNvSpPr/>
            <p:nvPr/>
          </p:nvSpPr>
          <p:spPr>
            <a:xfrm>
              <a:off x="4884480" y="4667040"/>
              <a:ext cx="627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NS p=0.1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1" name="文本框 150"/>
            <p:cNvSpPr/>
            <p:nvPr/>
          </p:nvSpPr>
          <p:spPr>
            <a:xfrm>
              <a:off x="3332520" y="5976720"/>
              <a:ext cx="77508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(ng/mL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2" name="文本框 14340"/>
            <p:cNvSpPr/>
            <p:nvPr/>
          </p:nvSpPr>
          <p:spPr>
            <a:xfrm>
              <a:off x="4095000" y="597708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3" name="文本框 14341"/>
            <p:cNvSpPr/>
            <p:nvPr/>
          </p:nvSpPr>
          <p:spPr>
            <a:xfrm>
              <a:off x="4367520" y="597708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4" name="文本框 14342"/>
            <p:cNvSpPr/>
            <p:nvPr/>
          </p:nvSpPr>
          <p:spPr>
            <a:xfrm>
              <a:off x="4710960" y="597708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5" name="文本框 14344"/>
            <p:cNvSpPr/>
            <p:nvPr/>
          </p:nvSpPr>
          <p:spPr>
            <a:xfrm>
              <a:off x="5054400" y="597708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86" name="文本框 101" descr=""/>
            <p:cNvPicPr/>
            <p:nvPr/>
          </p:nvPicPr>
          <p:blipFill>
            <a:blip r:embed="rId4"/>
            <a:stretch/>
          </p:blipFill>
          <p:spPr>
            <a:xfrm>
              <a:off x="3555720" y="4468680"/>
              <a:ext cx="336240" cy="1429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7" name="文本框 145"/>
            <p:cNvSpPr/>
            <p:nvPr/>
          </p:nvSpPr>
          <p:spPr>
            <a:xfrm>
              <a:off x="3755160" y="47253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8" name="文本框 146"/>
            <p:cNvSpPr/>
            <p:nvPr/>
          </p:nvSpPr>
          <p:spPr>
            <a:xfrm>
              <a:off x="3755160" y="50058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9" name="文本框 147"/>
            <p:cNvSpPr/>
            <p:nvPr/>
          </p:nvSpPr>
          <p:spPr>
            <a:xfrm>
              <a:off x="3755160" y="528660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0" name="文本框 172"/>
            <p:cNvSpPr/>
            <p:nvPr/>
          </p:nvSpPr>
          <p:spPr>
            <a:xfrm>
              <a:off x="3755160" y="55670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1" name="文本框 172"/>
            <p:cNvSpPr/>
            <p:nvPr/>
          </p:nvSpPr>
          <p:spPr>
            <a:xfrm>
              <a:off x="3755160" y="58478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92" name="Text Box 2"/>
          <p:cNvSpPr/>
          <p:nvPr/>
        </p:nvSpPr>
        <p:spPr>
          <a:xfrm>
            <a:off x="355680" y="4305240"/>
            <a:ext cx="40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3" name="组合 11"/>
          <p:cNvGrpSpPr/>
          <p:nvPr/>
        </p:nvGrpSpPr>
        <p:grpSpPr>
          <a:xfrm>
            <a:off x="-128520" y="219240"/>
            <a:ext cx="5676840" cy="2657160"/>
            <a:chOff x="-128520" y="219240"/>
            <a:chExt cx="5676840" cy="2657160"/>
          </a:xfrm>
        </p:grpSpPr>
        <p:pic>
          <p:nvPicPr>
            <p:cNvPr id="594" name="图片 6" descr="WT-2.tif"/>
            <p:cNvPicPr/>
            <p:nvPr/>
          </p:nvPicPr>
          <p:blipFill>
            <a:blip r:embed="rId5"/>
            <a:stretch/>
          </p:blipFill>
          <p:spPr>
            <a:xfrm>
              <a:off x="3241800" y="1797120"/>
              <a:ext cx="1079280" cy="107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5" name="图片 5" descr="CONTROL -2.tif"/>
            <p:cNvPicPr/>
            <p:nvPr/>
          </p:nvPicPr>
          <p:blipFill>
            <a:blip r:embed="rId6"/>
            <a:stretch/>
          </p:blipFill>
          <p:spPr>
            <a:xfrm>
              <a:off x="3245040" y="544320"/>
              <a:ext cx="1079280" cy="107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6" name="图片 4" descr="DAY1-3 20X -4.tif"/>
            <p:cNvPicPr/>
            <p:nvPr/>
          </p:nvPicPr>
          <p:blipFill>
            <a:blip r:embed="rId7"/>
            <a:stretch/>
          </p:blipFill>
          <p:spPr>
            <a:xfrm>
              <a:off x="2014200" y="1797120"/>
              <a:ext cx="1080720" cy="107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7" name="图片 3" descr="b4-1.tif"/>
            <p:cNvPicPr/>
            <p:nvPr/>
          </p:nvPicPr>
          <p:blipFill>
            <a:blip r:embed="rId8"/>
            <a:stretch/>
          </p:blipFill>
          <p:spPr>
            <a:xfrm>
              <a:off x="2022480" y="544320"/>
              <a:ext cx="1079280" cy="107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8" name="Picture 9" descr="J:\细胞形态变化\2014-6-23 r1r2r3\control\day0 100x.tif"/>
            <p:cNvPicPr/>
            <p:nvPr/>
          </p:nvPicPr>
          <p:blipFill>
            <a:blip r:embed="rId9"/>
            <a:stretch/>
          </p:blipFill>
          <p:spPr>
            <a:xfrm>
              <a:off x="797760" y="552600"/>
              <a:ext cx="107964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9" name="TextBox 58"/>
            <p:cNvSpPr/>
            <p:nvPr/>
          </p:nvSpPr>
          <p:spPr>
            <a:xfrm>
              <a:off x="671040" y="219240"/>
              <a:ext cx="887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0" name="TextBox 60"/>
            <p:cNvSpPr/>
            <p:nvPr/>
          </p:nvSpPr>
          <p:spPr>
            <a:xfrm>
              <a:off x="1873080" y="219240"/>
              <a:ext cx="887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01" name="Picture 2" descr="J:\细胞形态变化\2014-6-23 r1r2r3\r2\day0 100x.tif"/>
            <p:cNvPicPr/>
            <p:nvPr/>
          </p:nvPicPr>
          <p:blipFill>
            <a:blip r:embed="rId10"/>
            <a:stretch/>
          </p:blipFill>
          <p:spPr>
            <a:xfrm>
              <a:off x="788400" y="1788840"/>
              <a:ext cx="107928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02" name="TextBox 61"/>
            <p:cNvSpPr/>
            <p:nvPr/>
          </p:nvSpPr>
          <p:spPr>
            <a:xfrm>
              <a:off x="3098880" y="219240"/>
              <a:ext cx="887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Day10</a:t>
              </a: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3" name="直线连接符 40"/>
            <p:cNvSpPr/>
            <p:nvPr/>
          </p:nvSpPr>
          <p:spPr>
            <a:xfrm>
              <a:off x="813600" y="1557000"/>
              <a:ext cx="286920" cy="0"/>
            </a:xfrm>
            <a:prstGeom prst="line">
              <a:avLst/>
            </a:prstGeom>
            <a:ln w="255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4" name="矩形 222"/>
            <p:cNvSpPr/>
            <p:nvPr/>
          </p:nvSpPr>
          <p:spPr>
            <a:xfrm>
              <a:off x="3276720" y="1828800"/>
              <a:ext cx="492120" cy="488880"/>
            </a:xfrm>
            <a:prstGeom prst="rect">
              <a:avLst/>
            </a:prstGeom>
            <a:noFill/>
            <a:ln w="12600">
              <a:solidFill>
                <a:srgbClr val="ffffff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5" name="直线连接符 42"/>
            <p:cNvSpPr/>
            <p:nvPr/>
          </p:nvSpPr>
          <p:spPr>
            <a:xfrm>
              <a:off x="2139840" y="1557000"/>
              <a:ext cx="283680" cy="0"/>
            </a:xfrm>
            <a:prstGeom prst="line">
              <a:avLst/>
            </a:prstGeom>
            <a:ln w="255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6" name="直接连接符 1"/>
            <p:cNvSpPr/>
            <p:nvPr/>
          </p:nvSpPr>
          <p:spPr>
            <a:xfrm flipV="1">
              <a:off x="3775320" y="552240"/>
              <a:ext cx="693360" cy="16812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7" name="直接连接符 2"/>
            <p:cNvSpPr/>
            <p:nvPr/>
          </p:nvSpPr>
          <p:spPr>
            <a:xfrm>
              <a:off x="3775320" y="1225440"/>
              <a:ext cx="693360" cy="39780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8" name="直接连接符 3"/>
            <p:cNvSpPr/>
            <p:nvPr/>
          </p:nvSpPr>
          <p:spPr>
            <a:xfrm flipV="1">
              <a:off x="3775320" y="1796760"/>
              <a:ext cx="693360" cy="3924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9" name="直接连接符 4"/>
            <p:cNvSpPr/>
            <p:nvPr/>
          </p:nvSpPr>
          <p:spPr>
            <a:xfrm>
              <a:off x="3775320" y="2317680"/>
              <a:ext cx="693360" cy="558360"/>
            </a:xfrm>
            <a:prstGeom prst="line">
              <a:avLst/>
            </a:prstGeom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0" name="直线连接符 133"/>
            <p:cNvSpPr/>
            <p:nvPr/>
          </p:nvSpPr>
          <p:spPr>
            <a:xfrm>
              <a:off x="813600" y="488880"/>
              <a:ext cx="3506760" cy="12600"/>
            </a:xfrm>
            <a:prstGeom prst="line">
              <a:avLst/>
            </a:prstGeom>
            <a:ln w="255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1" name="Text Box 139"/>
            <p:cNvSpPr/>
            <p:nvPr/>
          </p:nvSpPr>
          <p:spPr>
            <a:xfrm>
              <a:off x="-128520" y="941040"/>
              <a:ext cx="899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2" name="Text Box 140"/>
            <p:cNvSpPr/>
            <p:nvPr/>
          </p:nvSpPr>
          <p:spPr>
            <a:xfrm>
              <a:off x="-128520" y="2252160"/>
              <a:ext cx="899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13" name="图片 225" descr="CONTROL -2.tif"/>
            <p:cNvPicPr/>
            <p:nvPr/>
          </p:nvPicPr>
          <p:blipFill>
            <a:blip r:embed="rId11"/>
            <a:stretch/>
          </p:blipFill>
          <p:spPr>
            <a:xfrm>
              <a:off x="4468680" y="544320"/>
              <a:ext cx="1079640" cy="1079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4" name="图片 226" descr="WT-2.tif"/>
            <p:cNvPicPr/>
            <p:nvPr/>
          </p:nvPicPr>
          <p:blipFill>
            <a:blip r:embed="rId12"/>
            <a:stretch/>
          </p:blipFill>
          <p:spPr>
            <a:xfrm>
              <a:off x="4468680" y="1797120"/>
              <a:ext cx="1079640" cy="1079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5" name="矩形 222"/>
            <p:cNvSpPr/>
            <p:nvPr/>
          </p:nvSpPr>
          <p:spPr>
            <a:xfrm>
              <a:off x="3273480" y="720720"/>
              <a:ext cx="501480" cy="504720"/>
            </a:xfrm>
            <a:prstGeom prst="rect">
              <a:avLst/>
            </a:prstGeom>
            <a:noFill/>
            <a:ln w="12600">
              <a:solidFill>
                <a:srgbClr val="ffffff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16" name="直线箭头连接符 12"/>
            <p:cNvCxnSpPr/>
            <p:nvPr/>
          </p:nvCxnSpPr>
          <p:spPr>
            <a:xfrm flipH="1">
              <a:off x="2581560" y="682560"/>
              <a:ext cx="170280" cy="241920"/>
            </a:xfrm>
            <a:prstGeom prst="straightConnector1">
              <a:avLst/>
            </a:prstGeom>
            <a:ln w="38160">
              <a:solidFill>
                <a:srgbClr val="ffffff"/>
              </a:solidFill>
              <a:round/>
              <a:tailEnd len="med" type="triangle" w="med"/>
            </a:ln>
          </p:spPr>
        </p:cxnSp>
        <p:cxnSp>
          <p:nvCxnSpPr>
            <p:cNvPr id="617" name="直线箭头连接符 234"/>
            <p:cNvCxnSpPr/>
            <p:nvPr/>
          </p:nvCxnSpPr>
          <p:spPr>
            <a:xfrm flipV="1">
              <a:off x="2317680" y="2196360"/>
              <a:ext cx="230400" cy="220680"/>
            </a:xfrm>
            <a:prstGeom prst="straightConnector1">
              <a:avLst/>
            </a:prstGeom>
            <a:ln w="38160">
              <a:solidFill>
                <a:srgbClr val="ffffff"/>
              </a:solidFill>
              <a:round/>
              <a:tailEnd len="med" type="triangle" w="med"/>
            </a:ln>
          </p:spPr>
        </p:cxnSp>
        <p:cxnSp>
          <p:nvCxnSpPr>
            <p:cNvPr id="618" name="直线箭头连接符 12"/>
            <p:cNvCxnSpPr/>
            <p:nvPr/>
          </p:nvCxnSpPr>
          <p:spPr>
            <a:xfrm flipH="1">
              <a:off x="5070600" y="720360"/>
              <a:ext cx="172080" cy="240120"/>
            </a:xfrm>
            <a:prstGeom prst="straightConnector1">
              <a:avLst/>
            </a:prstGeom>
            <a:ln w="38160">
              <a:solidFill>
                <a:srgbClr val="ffffff"/>
              </a:solidFill>
              <a:round/>
              <a:tailEnd len="med" type="triangle" w="med"/>
            </a:ln>
          </p:spPr>
        </p:cxnSp>
        <p:cxnSp>
          <p:nvCxnSpPr>
            <p:cNvPr id="619" name="直线箭头连接符 12"/>
            <p:cNvCxnSpPr/>
            <p:nvPr/>
          </p:nvCxnSpPr>
          <p:spPr>
            <a:xfrm flipH="1">
              <a:off x="5198760" y="1858680"/>
              <a:ext cx="103680" cy="316080"/>
            </a:xfrm>
            <a:prstGeom prst="straightConnector1">
              <a:avLst/>
            </a:prstGeom>
            <a:ln w="38160">
              <a:solidFill>
                <a:srgbClr val="ffffff"/>
              </a:solidFill>
              <a:round/>
              <a:tailEnd len="med" type="triangle" w="med"/>
            </a:ln>
          </p:spPr>
        </p:cxnSp>
        <p:cxnSp>
          <p:nvCxnSpPr>
            <p:cNvPr id="620" name="直线箭头连接符 12"/>
            <p:cNvCxnSpPr/>
            <p:nvPr/>
          </p:nvCxnSpPr>
          <p:spPr>
            <a:xfrm flipH="1" flipV="1">
              <a:off x="4905360" y="2498040"/>
              <a:ext cx="236880" cy="186120"/>
            </a:xfrm>
            <a:prstGeom prst="straightConnector1">
              <a:avLst/>
            </a:prstGeom>
            <a:ln w="38160">
              <a:solidFill>
                <a:srgbClr val="ffffff"/>
              </a:solidFill>
              <a:round/>
              <a:tailEnd len="med" type="triangle" w="med"/>
            </a:ln>
          </p:spPr>
        </p:cxnSp>
        <p:sp>
          <p:nvSpPr>
            <p:cNvPr id="621" name="文本框 1"/>
            <p:cNvSpPr/>
            <p:nvPr/>
          </p:nvSpPr>
          <p:spPr>
            <a:xfrm>
              <a:off x="1131480" y="1528560"/>
              <a:ext cx="420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Calibri"/>
                </a:rPr>
                <a:t>20u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2" name="文本框 118"/>
            <p:cNvSpPr/>
            <p:nvPr/>
          </p:nvSpPr>
          <p:spPr>
            <a:xfrm>
              <a:off x="2460240" y="1533600"/>
              <a:ext cx="471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Calibri"/>
                </a:rPr>
                <a:t>100u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23" name="组 1"/>
          <p:cNvGrpSpPr/>
          <p:nvPr/>
        </p:nvGrpSpPr>
        <p:grpSpPr>
          <a:xfrm>
            <a:off x="-93600" y="6558120"/>
            <a:ext cx="5464080" cy="1728720"/>
            <a:chOff x="-93600" y="6558120"/>
            <a:chExt cx="5464080" cy="1728720"/>
          </a:xfrm>
        </p:grpSpPr>
        <p:pic>
          <p:nvPicPr>
            <p:cNvPr id="624" name="图片 11" descr="1.tif"/>
            <p:cNvPicPr/>
            <p:nvPr/>
          </p:nvPicPr>
          <p:blipFill>
            <a:blip r:embed="rId13"/>
            <a:stretch/>
          </p:blipFill>
          <p:spPr>
            <a:xfrm>
              <a:off x="3213000" y="6811560"/>
              <a:ext cx="1014480" cy="698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5" name="文本框 12"/>
            <p:cNvSpPr/>
            <p:nvPr/>
          </p:nvSpPr>
          <p:spPr>
            <a:xfrm>
              <a:off x="1383480" y="6558120"/>
              <a:ext cx="709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FU-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6" name="文本框 202"/>
            <p:cNvSpPr/>
            <p:nvPr/>
          </p:nvSpPr>
          <p:spPr>
            <a:xfrm>
              <a:off x="3339000" y="6558120"/>
              <a:ext cx="947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FU-G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7" name="文本框 205"/>
            <p:cNvSpPr/>
            <p:nvPr/>
          </p:nvSpPr>
          <p:spPr>
            <a:xfrm>
              <a:off x="4245840" y="6558120"/>
              <a:ext cx="1124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FU-GEM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28" name="Picture 2" descr="CFU-GEMM 20X"/>
            <p:cNvPicPr/>
            <p:nvPr/>
          </p:nvPicPr>
          <p:blipFill>
            <a:blip r:embed="rId14"/>
            <a:stretch/>
          </p:blipFill>
          <p:spPr>
            <a:xfrm>
              <a:off x="4259880" y="6811560"/>
              <a:ext cx="1014480" cy="69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9" name="图片 10" descr="Captured.gif"/>
            <p:cNvPicPr/>
            <p:nvPr/>
          </p:nvPicPr>
          <p:blipFill>
            <a:blip r:embed="rId15"/>
            <a:stretch/>
          </p:blipFill>
          <p:spPr>
            <a:xfrm>
              <a:off x="4259880" y="7588800"/>
              <a:ext cx="1014480" cy="69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0" name="图片 11" descr="G4.jpg"/>
            <p:cNvPicPr/>
            <p:nvPr/>
          </p:nvPicPr>
          <p:blipFill>
            <a:blip r:embed="rId16"/>
            <a:stretch/>
          </p:blipFill>
          <p:spPr>
            <a:xfrm>
              <a:off x="3213000" y="7588800"/>
              <a:ext cx="1014480" cy="698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1" name="文本框 12"/>
            <p:cNvSpPr/>
            <p:nvPr/>
          </p:nvSpPr>
          <p:spPr>
            <a:xfrm>
              <a:off x="2411280" y="6558120"/>
              <a:ext cx="709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FU-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32" name="图片 14" descr="E-3.tif"/>
            <p:cNvPicPr/>
            <p:nvPr/>
          </p:nvPicPr>
          <p:blipFill>
            <a:blip r:embed="rId17"/>
            <a:stretch/>
          </p:blipFill>
          <p:spPr>
            <a:xfrm>
              <a:off x="2165760" y="6811560"/>
              <a:ext cx="1014480" cy="69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3" name="图片 15" descr="E-4.tif"/>
            <p:cNvPicPr/>
            <p:nvPr/>
          </p:nvPicPr>
          <p:blipFill>
            <a:blip r:embed="rId18"/>
            <a:stretch/>
          </p:blipFill>
          <p:spPr>
            <a:xfrm>
              <a:off x="2165760" y="7588800"/>
              <a:ext cx="1014480" cy="69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4" name="图片 18" descr="E-2.tif"/>
            <p:cNvPicPr/>
            <p:nvPr/>
          </p:nvPicPr>
          <p:blipFill>
            <a:blip r:embed="rId19"/>
            <a:stretch/>
          </p:blipFill>
          <p:spPr>
            <a:xfrm>
              <a:off x="1118880" y="7588800"/>
              <a:ext cx="1014480" cy="698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5" name="图片 19" descr="CFU-E.gif"/>
            <p:cNvPicPr/>
            <p:nvPr/>
          </p:nvPicPr>
          <p:blipFill>
            <a:blip r:embed="rId20"/>
            <a:stretch/>
          </p:blipFill>
          <p:spPr>
            <a:xfrm>
              <a:off x="1118880" y="6811560"/>
              <a:ext cx="1014480" cy="698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6" name="Text Box 139"/>
            <p:cNvSpPr/>
            <p:nvPr/>
          </p:nvSpPr>
          <p:spPr>
            <a:xfrm>
              <a:off x="319320" y="7034400"/>
              <a:ext cx="841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7" name="Text Box 140"/>
            <p:cNvSpPr/>
            <p:nvPr/>
          </p:nvSpPr>
          <p:spPr>
            <a:xfrm>
              <a:off x="-93600" y="7775640"/>
              <a:ext cx="125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38" name="Text Box 2"/>
          <p:cNvSpPr/>
          <p:nvPr/>
        </p:nvSpPr>
        <p:spPr>
          <a:xfrm>
            <a:off x="355680" y="6388200"/>
            <a:ext cx="40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9" name="Text Box 2"/>
          <p:cNvSpPr/>
          <p:nvPr/>
        </p:nvSpPr>
        <p:spPr>
          <a:xfrm>
            <a:off x="3282840" y="4305240"/>
            <a:ext cx="40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0" name="图片 32" descr=""/>
          <p:cNvPicPr/>
          <p:nvPr/>
        </p:nvPicPr>
        <p:blipFill>
          <a:blip r:embed="rId21"/>
          <a:stretch/>
        </p:blipFill>
        <p:spPr>
          <a:xfrm>
            <a:off x="939960" y="3225960"/>
            <a:ext cx="963360" cy="1079280"/>
          </a:xfrm>
          <a:prstGeom prst="rect">
            <a:avLst/>
          </a:prstGeom>
          <a:ln w="0">
            <a:noFill/>
          </a:ln>
        </p:spPr>
      </p:pic>
      <p:pic>
        <p:nvPicPr>
          <p:cNvPr id="641" name="图片 34" descr=""/>
          <p:cNvPicPr/>
          <p:nvPr/>
        </p:nvPicPr>
        <p:blipFill>
          <a:blip r:embed="rId22"/>
          <a:stretch/>
        </p:blipFill>
        <p:spPr>
          <a:xfrm>
            <a:off x="1878120" y="3225960"/>
            <a:ext cx="963360" cy="1079280"/>
          </a:xfrm>
          <a:prstGeom prst="rect">
            <a:avLst/>
          </a:prstGeom>
          <a:ln w="0">
            <a:noFill/>
          </a:ln>
        </p:spPr>
      </p:pic>
      <p:sp>
        <p:nvSpPr>
          <p:cNvPr id="642" name="Text Box 140"/>
          <p:cNvSpPr/>
          <p:nvPr/>
        </p:nvSpPr>
        <p:spPr>
          <a:xfrm>
            <a:off x="1897200" y="3052800"/>
            <a:ext cx="798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R-spondin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3" name="Text Box 139"/>
          <p:cNvSpPr/>
          <p:nvPr/>
        </p:nvSpPr>
        <p:spPr>
          <a:xfrm>
            <a:off x="1081080" y="3046320"/>
            <a:ext cx="730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r>
              <a:rPr b="0" lang="zh-CN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4" name="Text Box 139"/>
          <p:cNvSpPr/>
          <p:nvPr/>
        </p:nvSpPr>
        <p:spPr>
          <a:xfrm>
            <a:off x="1635120" y="4221000"/>
            <a:ext cx="590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CD43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5" name="文本框 3" descr=""/>
          <p:cNvPicPr/>
          <p:nvPr/>
        </p:nvPicPr>
        <p:blipFill>
          <a:blip r:embed="rId23"/>
          <a:stretch/>
        </p:blipFill>
        <p:spPr>
          <a:xfrm>
            <a:off x="689040" y="3295800"/>
            <a:ext cx="322200" cy="561960"/>
          </a:xfrm>
          <a:prstGeom prst="rect">
            <a:avLst/>
          </a:prstGeom>
          <a:ln w="0">
            <a:noFill/>
          </a:ln>
        </p:spPr>
      </p:pic>
      <p:pic>
        <p:nvPicPr>
          <p:cNvPr id="646" name="图片 35" descr=""/>
          <p:cNvPicPr/>
          <p:nvPr/>
        </p:nvPicPr>
        <p:blipFill>
          <a:blip r:embed="rId24"/>
          <a:stretch/>
        </p:blipFill>
        <p:spPr>
          <a:xfrm>
            <a:off x="3645000" y="3225960"/>
            <a:ext cx="965160" cy="1079280"/>
          </a:xfrm>
          <a:prstGeom prst="rect">
            <a:avLst/>
          </a:prstGeom>
          <a:ln w="0">
            <a:noFill/>
          </a:ln>
        </p:spPr>
      </p:pic>
      <p:pic>
        <p:nvPicPr>
          <p:cNvPr id="647" name="图片 38" descr=""/>
          <p:cNvPicPr/>
          <p:nvPr/>
        </p:nvPicPr>
        <p:blipFill>
          <a:blip r:embed="rId25"/>
          <a:stretch/>
        </p:blipFill>
        <p:spPr>
          <a:xfrm>
            <a:off x="4584600" y="3225960"/>
            <a:ext cx="963720" cy="1079280"/>
          </a:xfrm>
          <a:prstGeom prst="rect">
            <a:avLst/>
          </a:prstGeom>
          <a:ln w="0">
            <a:noFill/>
          </a:ln>
        </p:spPr>
      </p:pic>
      <p:sp>
        <p:nvSpPr>
          <p:cNvPr id="648" name="Text Box 139"/>
          <p:cNvSpPr/>
          <p:nvPr/>
        </p:nvSpPr>
        <p:spPr>
          <a:xfrm>
            <a:off x="4356000" y="4221000"/>
            <a:ext cx="588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CD45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9" name="文本框 5" descr=""/>
          <p:cNvPicPr/>
          <p:nvPr/>
        </p:nvPicPr>
        <p:blipFill>
          <a:blip r:embed="rId26"/>
          <a:stretch/>
        </p:blipFill>
        <p:spPr>
          <a:xfrm>
            <a:off x="3409920" y="3295800"/>
            <a:ext cx="320760" cy="561960"/>
          </a:xfrm>
          <a:prstGeom prst="rect">
            <a:avLst/>
          </a:prstGeom>
          <a:ln w="0">
            <a:noFill/>
          </a:ln>
        </p:spPr>
      </p:pic>
      <p:sp>
        <p:nvSpPr>
          <p:cNvPr id="650" name="Text Box 140"/>
          <p:cNvSpPr/>
          <p:nvPr/>
        </p:nvSpPr>
        <p:spPr>
          <a:xfrm>
            <a:off x="4648320" y="3052800"/>
            <a:ext cx="798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R-spondin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1" name="Text Box 139"/>
          <p:cNvSpPr/>
          <p:nvPr/>
        </p:nvSpPr>
        <p:spPr>
          <a:xfrm>
            <a:off x="3760920" y="3046320"/>
            <a:ext cx="730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r>
              <a:rPr b="0" lang="zh-CN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2" name="Text Box 2"/>
          <p:cNvSpPr/>
          <p:nvPr/>
        </p:nvSpPr>
        <p:spPr>
          <a:xfrm>
            <a:off x="385920" y="3060720"/>
            <a:ext cx="40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3" name="Text Box 2"/>
          <p:cNvSpPr/>
          <p:nvPr/>
        </p:nvSpPr>
        <p:spPr>
          <a:xfrm>
            <a:off x="3244680" y="3060720"/>
            <a:ext cx="403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03T19:02:00Z</dcterms:created>
  <dc:creator>yu wang</dc:creator>
  <dc:description/>
  <dc:language>en-US</dc:language>
  <cp:lastModifiedBy>yuwang</cp:lastModifiedBy>
  <dcterms:modified xsi:type="dcterms:W3CDTF">2019-03-26T23:18:45Z</dcterms:modified>
  <cp:revision>247</cp:revision>
  <dc:subject/>
  <dc:title>PowerPoint ʾĸ�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.0.0.1087</vt:lpwstr>
  </property>
</Properties>
</file>